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D4B190-5CA8-4E8E-BF54-BF5074638717}" v="1" dt="2025-01-06T13:36:08.682"/>
    <p1510:client id="{A916F4E8-0BF3-4E29-9A5E-B6140E016C35}" v="67" dt="2025-01-06T13:59:57.416"/>
    <p1510:client id="{BBEB0CBE-D9E2-4B1C-A0C2-4B887481E6F9}" v="60" dt="2025-01-06T16:20:03.0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02"/>
    <p:restoredTop sz="94705"/>
  </p:normalViewPr>
  <p:slideViewPr>
    <p:cSldViewPr snapToGrid="0">
      <p:cViewPr>
        <p:scale>
          <a:sx n="70" d="100"/>
          <a:sy n="70" d="100"/>
        </p:scale>
        <p:origin x="396" y="-372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uke Flower" userId="VIGurbg40yMvIKMHIK2kyFqy7DkJde+0x8qwP7gx9no=" providerId="None" clId="Web-{0DD4B190-5CA8-4E8E-BF54-BF5074638717}"/>
    <pc:docChg chg="modSld">
      <pc:chgData name="Luke Flower" userId="VIGurbg40yMvIKMHIK2kyFqy7DkJde+0x8qwP7gx9no=" providerId="None" clId="Web-{0DD4B190-5CA8-4E8E-BF54-BF5074638717}" dt="2025-01-06T13:36:08.682" v="0"/>
      <pc:docMkLst>
        <pc:docMk/>
      </pc:docMkLst>
      <pc:sldChg chg="addSp">
        <pc:chgData name="Luke Flower" userId="VIGurbg40yMvIKMHIK2kyFqy7DkJde+0x8qwP7gx9no=" providerId="None" clId="Web-{0DD4B190-5CA8-4E8E-BF54-BF5074638717}" dt="2025-01-06T13:36:08.682" v="0"/>
        <pc:sldMkLst>
          <pc:docMk/>
          <pc:sldMk cId="0" sldId="257"/>
        </pc:sldMkLst>
        <pc:grpChg chg="add">
          <ac:chgData name="Luke Flower" userId="VIGurbg40yMvIKMHIK2kyFqy7DkJde+0x8qwP7gx9no=" providerId="None" clId="Web-{0DD4B190-5CA8-4E8E-BF54-BF5074638717}" dt="2025-01-06T13:36:08.682" v="0"/>
          <ac:grpSpMkLst>
            <pc:docMk/>
            <pc:sldMk cId="0" sldId="257"/>
            <ac:grpSpMk id="2" creationId="{F264B294-A22D-E5C7-E885-88E1200C0077}"/>
          </ac:grpSpMkLst>
        </pc:grpChg>
      </pc:sldChg>
    </pc:docChg>
  </pc:docChgLst>
  <pc:docChgLst>
    <pc:chgData name="Luke Flower" userId="VIGurbg40yMvIKMHIK2kyFqy7DkJde+0x8qwP7gx9no=" providerId="None" clId="Web-{A916F4E8-0BF3-4E29-9A5E-B6140E016C35}"/>
    <pc:docChg chg="modSld">
      <pc:chgData name="Luke Flower" userId="VIGurbg40yMvIKMHIK2kyFqy7DkJde+0x8qwP7gx9no=" providerId="None" clId="Web-{A916F4E8-0BF3-4E29-9A5E-B6140E016C35}" dt="2025-01-06T13:59:57.416" v="66" actId="14100"/>
      <pc:docMkLst>
        <pc:docMk/>
      </pc:docMkLst>
      <pc:sldChg chg="modSp">
        <pc:chgData name="Luke Flower" userId="VIGurbg40yMvIKMHIK2kyFqy7DkJde+0x8qwP7gx9no=" providerId="None" clId="Web-{A916F4E8-0BF3-4E29-9A5E-B6140E016C35}" dt="2025-01-06T13:59:57.416" v="66" actId="14100"/>
        <pc:sldMkLst>
          <pc:docMk/>
          <pc:sldMk cId="0" sldId="257"/>
        </pc:sldMkLst>
        <pc:spChg chg="mod">
          <ac:chgData name="Luke Flower" userId="VIGurbg40yMvIKMHIK2kyFqy7DkJde+0x8qwP7gx9no=" providerId="None" clId="Web-{A916F4E8-0BF3-4E29-9A5E-B6140E016C35}" dt="2025-01-06T13:57:49.052" v="30" actId="14100"/>
          <ac:spMkLst>
            <pc:docMk/>
            <pc:sldMk cId="0" sldId="257"/>
            <ac:spMk id="18" creationId="{8AF99871-28AC-3EBD-396B-D19920FF59EB}"/>
          </ac:spMkLst>
        </pc:spChg>
        <pc:spChg chg="mod">
          <ac:chgData name="Luke Flower" userId="VIGurbg40yMvIKMHIK2kyFqy7DkJde+0x8qwP7gx9no=" providerId="None" clId="Web-{A916F4E8-0BF3-4E29-9A5E-B6140E016C35}" dt="2025-01-06T13:58:47.023" v="49" actId="14100"/>
          <ac:spMkLst>
            <pc:docMk/>
            <pc:sldMk cId="0" sldId="257"/>
            <ac:spMk id="100" creationId="{00000000-0000-0000-0000-000000000000}"/>
          </ac:spMkLst>
        </pc:spChg>
        <pc:spChg chg="mod">
          <ac:chgData name="Luke Flower" userId="VIGurbg40yMvIKMHIK2kyFqy7DkJde+0x8qwP7gx9no=" providerId="None" clId="Web-{A916F4E8-0BF3-4E29-9A5E-B6140E016C35}" dt="2025-01-06T13:55:20.172" v="3" actId="14100"/>
          <ac:spMkLst>
            <pc:docMk/>
            <pc:sldMk cId="0" sldId="257"/>
            <ac:spMk id="106" creationId="{00000000-0000-0000-0000-000000000000}"/>
          </ac:spMkLst>
        </pc:spChg>
        <pc:grpChg chg="mod">
          <ac:chgData name="Luke Flower" userId="VIGurbg40yMvIKMHIK2kyFqy7DkJde+0x8qwP7gx9no=" providerId="None" clId="Web-{A916F4E8-0BF3-4E29-9A5E-B6140E016C35}" dt="2025-01-06T13:59:49.603" v="65" actId="14100"/>
          <ac:grpSpMkLst>
            <pc:docMk/>
            <pc:sldMk cId="0" sldId="257"/>
            <ac:grpSpMk id="2" creationId="{F264B294-A22D-E5C7-E885-88E1200C0077}"/>
          </ac:grpSpMkLst>
        </pc:grpChg>
        <pc:picChg chg="mod">
          <ac:chgData name="Luke Flower" userId="VIGurbg40yMvIKMHIK2kyFqy7DkJde+0x8qwP7gx9no=" providerId="None" clId="Web-{A916F4E8-0BF3-4E29-9A5E-B6140E016C35}" dt="2025-01-06T13:59:57.416" v="66" actId="14100"/>
          <ac:picMkLst>
            <pc:docMk/>
            <pc:sldMk cId="0" sldId="257"/>
            <ac:picMk id="3" creationId="{E2DADB9B-345E-537D-5F9F-E5E115818827}"/>
          </ac:picMkLst>
        </pc:picChg>
        <pc:picChg chg="mod">
          <ac:chgData name="Luke Flower" userId="VIGurbg40yMvIKMHIK2kyFqy7DkJde+0x8qwP7gx9no=" providerId="None" clId="Web-{A916F4E8-0BF3-4E29-9A5E-B6140E016C35}" dt="2025-01-06T13:59:17.258" v="61" actId="14100"/>
          <ac:picMkLst>
            <pc:docMk/>
            <pc:sldMk cId="0" sldId="257"/>
            <ac:picMk id="10" creationId="{162E93B4-E0B8-268B-A4EE-02AD7E923D20}"/>
          </ac:picMkLst>
        </pc:picChg>
        <pc:picChg chg="mod">
          <ac:chgData name="Luke Flower" userId="VIGurbg40yMvIKMHIK2kyFqy7DkJde+0x8qwP7gx9no=" providerId="None" clId="Web-{A916F4E8-0BF3-4E29-9A5E-B6140E016C35}" dt="2025-01-06T13:59:17.258" v="60" actId="14100"/>
          <ac:picMkLst>
            <pc:docMk/>
            <pc:sldMk cId="0" sldId="257"/>
            <ac:picMk id="12" creationId="{48604C92-4556-AADA-FC5A-A400F9EE3717}"/>
          </ac:picMkLst>
        </pc:picChg>
        <pc:picChg chg="mod">
          <ac:chgData name="Luke Flower" userId="VIGurbg40yMvIKMHIK2kyFqy7DkJde+0x8qwP7gx9no=" providerId="None" clId="Web-{A916F4E8-0BF3-4E29-9A5E-B6140E016C35}" dt="2025-01-06T13:59:17.258" v="59" actId="14100"/>
          <ac:picMkLst>
            <pc:docMk/>
            <pc:sldMk cId="0" sldId="257"/>
            <ac:picMk id="14" creationId="{F0DAF36A-0511-1935-DCFF-A6F60679E53E}"/>
          </ac:picMkLst>
        </pc:picChg>
        <pc:picChg chg="mod">
          <ac:chgData name="Luke Flower" userId="VIGurbg40yMvIKMHIK2kyFqy7DkJde+0x8qwP7gx9no=" providerId="None" clId="Web-{A916F4E8-0BF3-4E29-9A5E-B6140E016C35}" dt="2025-01-06T13:59:17.258" v="58" actId="14100"/>
          <ac:picMkLst>
            <pc:docMk/>
            <pc:sldMk cId="0" sldId="257"/>
            <ac:picMk id="17" creationId="{313CD06F-035D-44AF-CC8C-3D481F9875C3}"/>
          </ac:picMkLst>
        </pc:picChg>
      </pc:sldChg>
    </pc:docChg>
  </pc:docChgLst>
  <pc:docChgLst>
    <pc:chgData name="Luke Flower" userId="VIGurbg40yMvIKMHIK2kyFqy7DkJde+0x8qwP7gx9no=" providerId="None" clId="Web-{BBEB0CBE-D9E2-4B1C-A0C2-4B887481E6F9}"/>
    <pc:docChg chg="modSld">
      <pc:chgData name="Luke Flower" userId="VIGurbg40yMvIKMHIK2kyFqy7DkJde+0x8qwP7gx9no=" providerId="None" clId="Web-{BBEB0CBE-D9E2-4B1C-A0C2-4B887481E6F9}" dt="2025-01-06T16:20:03.035" v="59" actId="1076"/>
      <pc:docMkLst>
        <pc:docMk/>
      </pc:docMkLst>
      <pc:sldChg chg="modSp">
        <pc:chgData name="Luke Flower" userId="VIGurbg40yMvIKMHIK2kyFqy7DkJde+0x8qwP7gx9no=" providerId="None" clId="Web-{BBEB0CBE-D9E2-4B1C-A0C2-4B887481E6F9}" dt="2025-01-06T16:20:03.035" v="59" actId="1076"/>
        <pc:sldMkLst>
          <pc:docMk/>
          <pc:sldMk cId="0" sldId="257"/>
        </pc:sldMkLst>
        <pc:spChg chg="mod">
          <ac:chgData name="Luke Flower" userId="VIGurbg40yMvIKMHIK2kyFqy7DkJde+0x8qwP7gx9no=" providerId="None" clId="Web-{BBEB0CBE-D9E2-4B1C-A0C2-4B887481E6F9}" dt="2025-01-06T16:20:03.035" v="49" actId="1076"/>
          <ac:spMkLst>
            <pc:docMk/>
            <pc:sldMk cId="0" sldId="257"/>
            <ac:spMk id="4" creationId="{256C6380-94A6-5DE7-BC6C-B5D196AC8644}"/>
          </ac:spMkLst>
        </pc:spChg>
        <pc:spChg chg="mod">
          <ac:chgData name="Luke Flower" userId="VIGurbg40yMvIKMHIK2kyFqy7DkJde+0x8qwP7gx9no=" providerId="None" clId="Web-{BBEB0CBE-D9E2-4B1C-A0C2-4B887481E6F9}" dt="2025-01-06T16:20:03.035" v="58" actId="1076"/>
          <ac:spMkLst>
            <pc:docMk/>
            <pc:sldMk cId="0" sldId="257"/>
            <ac:spMk id="98" creationId="{00000000-0000-0000-0000-000000000000}"/>
          </ac:spMkLst>
        </pc:spChg>
        <pc:spChg chg="mod">
          <ac:chgData name="Luke Flower" userId="VIGurbg40yMvIKMHIK2kyFqy7DkJde+0x8qwP7gx9no=" providerId="None" clId="Web-{BBEB0CBE-D9E2-4B1C-A0C2-4B887481E6F9}" dt="2025-01-06T16:20:03.035" v="59" actId="1076"/>
          <ac:spMkLst>
            <pc:docMk/>
            <pc:sldMk cId="0" sldId="257"/>
            <ac:spMk id="100" creationId="{00000000-0000-0000-0000-000000000000}"/>
          </ac:spMkLst>
        </pc:spChg>
        <pc:spChg chg="mod">
          <ac:chgData name="Luke Flower" userId="VIGurbg40yMvIKMHIK2kyFqy7DkJde+0x8qwP7gx9no=" providerId="None" clId="Web-{BBEB0CBE-D9E2-4B1C-A0C2-4B887481E6F9}" dt="2025-01-06T16:20:03.035" v="56" actId="1076"/>
          <ac:spMkLst>
            <pc:docMk/>
            <pc:sldMk cId="0" sldId="257"/>
            <ac:spMk id="104" creationId="{00000000-0000-0000-0000-000000000000}"/>
          </ac:spMkLst>
        </pc:spChg>
        <pc:spChg chg="mod">
          <ac:chgData name="Luke Flower" userId="VIGurbg40yMvIKMHIK2kyFqy7DkJde+0x8qwP7gx9no=" providerId="None" clId="Web-{BBEB0CBE-D9E2-4B1C-A0C2-4B887481E6F9}" dt="2025-01-06T16:20:03.035" v="55" actId="1076"/>
          <ac:spMkLst>
            <pc:docMk/>
            <pc:sldMk cId="0" sldId="257"/>
            <ac:spMk id="105" creationId="{00000000-0000-0000-0000-000000000000}"/>
          </ac:spMkLst>
        </pc:spChg>
        <pc:grpChg chg="mod">
          <ac:chgData name="Luke Flower" userId="VIGurbg40yMvIKMHIK2kyFqy7DkJde+0x8qwP7gx9no=" providerId="None" clId="Web-{BBEB0CBE-D9E2-4B1C-A0C2-4B887481E6F9}" dt="2025-01-06T16:20:03.035" v="54" actId="1076"/>
          <ac:grpSpMkLst>
            <pc:docMk/>
            <pc:sldMk cId="0" sldId="257"/>
            <ac:grpSpMk id="2" creationId="{F264B294-A22D-E5C7-E885-88E1200C0077}"/>
          </ac:grpSpMkLst>
        </pc:grpChg>
        <pc:grpChg chg="mod">
          <ac:chgData name="Luke Flower" userId="VIGurbg40yMvIKMHIK2kyFqy7DkJde+0x8qwP7gx9no=" providerId="None" clId="Web-{BBEB0CBE-D9E2-4B1C-A0C2-4B887481E6F9}" dt="2025-01-06T16:20:03.035" v="57" actId="1076"/>
          <ac:grpSpMkLst>
            <pc:docMk/>
            <pc:sldMk cId="0" sldId="257"/>
            <ac:grpSpMk id="101" creationId="{00000000-0000-0000-0000-000000000000}"/>
          </ac:grpSpMkLst>
        </pc:grpChg>
        <pc:picChg chg="mod">
          <ac:chgData name="Luke Flower" userId="VIGurbg40yMvIKMHIK2kyFqy7DkJde+0x8qwP7gx9no=" providerId="None" clId="Web-{BBEB0CBE-D9E2-4B1C-A0C2-4B887481E6F9}" dt="2025-01-06T16:20:03.035" v="50" actId="1076"/>
          <ac:picMkLst>
            <pc:docMk/>
            <pc:sldMk cId="0" sldId="257"/>
            <ac:picMk id="3" creationId="{E2DADB9B-345E-537D-5F9F-E5E115818827}"/>
          </ac:picMkLst>
        </pc:picChg>
        <pc:picChg chg="mod">
          <ac:chgData name="Luke Flower" userId="VIGurbg40yMvIKMHIK2kyFqy7DkJde+0x8qwP7gx9no=" providerId="None" clId="Web-{BBEB0CBE-D9E2-4B1C-A0C2-4B887481E6F9}" dt="2025-01-06T16:20:03.035" v="48" actId="1076"/>
          <ac:picMkLst>
            <pc:docMk/>
            <pc:sldMk cId="0" sldId="257"/>
            <ac:picMk id="10" creationId="{162E93B4-E0B8-268B-A4EE-02AD7E923D20}"/>
          </ac:picMkLst>
        </pc:picChg>
        <pc:picChg chg="mod">
          <ac:chgData name="Luke Flower" userId="VIGurbg40yMvIKMHIK2kyFqy7DkJde+0x8qwP7gx9no=" providerId="None" clId="Web-{BBEB0CBE-D9E2-4B1C-A0C2-4B887481E6F9}" dt="2025-01-06T16:20:03.035" v="47" actId="1076"/>
          <ac:picMkLst>
            <pc:docMk/>
            <pc:sldMk cId="0" sldId="257"/>
            <ac:picMk id="12" creationId="{48604C92-4556-AADA-FC5A-A400F9EE3717}"/>
          </ac:picMkLst>
        </pc:picChg>
        <pc:picChg chg="mod">
          <ac:chgData name="Luke Flower" userId="VIGurbg40yMvIKMHIK2kyFqy7DkJde+0x8qwP7gx9no=" providerId="None" clId="Web-{BBEB0CBE-D9E2-4B1C-A0C2-4B887481E6F9}" dt="2025-01-06T16:20:03.035" v="46" actId="1076"/>
          <ac:picMkLst>
            <pc:docMk/>
            <pc:sldMk cId="0" sldId="257"/>
            <ac:picMk id="14" creationId="{F0DAF36A-0511-1935-DCFF-A6F60679E53E}"/>
          </ac:picMkLst>
        </pc:picChg>
        <pc:picChg chg="mod">
          <ac:chgData name="Luke Flower" userId="VIGurbg40yMvIKMHIK2kyFqy7DkJde+0x8qwP7gx9no=" providerId="None" clId="Web-{BBEB0CBE-D9E2-4B1C-A0C2-4B887481E6F9}" dt="2025-01-06T16:20:03.019" v="45" actId="1076"/>
          <ac:picMkLst>
            <pc:docMk/>
            <pc:sldMk cId="0" sldId="257"/>
            <ac:picMk id="17" creationId="{313CD06F-035D-44AF-CC8C-3D481F9875C3}"/>
          </ac:picMkLst>
        </pc:picChg>
        <pc:picChg chg="mod">
          <ac:chgData name="Luke Flower" userId="VIGurbg40yMvIKMHIK2kyFqy7DkJde+0x8qwP7gx9no=" providerId="None" clId="Web-{BBEB0CBE-D9E2-4B1C-A0C2-4B887481E6F9}" dt="2025-01-06T16:20:03.035" v="53" actId="1076"/>
          <ac:picMkLst>
            <pc:docMk/>
            <pc:sldMk cId="0" sldId="257"/>
            <ac:picMk id="109" creationId="{00000000-0000-0000-0000-000000000000}"/>
          </ac:picMkLst>
        </pc:picChg>
        <pc:picChg chg="mod">
          <ac:chgData name="Luke Flower" userId="VIGurbg40yMvIKMHIK2kyFqy7DkJde+0x8qwP7gx9no=" providerId="None" clId="Web-{BBEB0CBE-D9E2-4B1C-A0C2-4B887481E6F9}" dt="2025-01-06T16:20:03.035" v="52" actId="1076"/>
          <ac:picMkLst>
            <pc:docMk/>
            <pc:sldMk cId="0" sldId="257"/>
            <ac:picMk id="110" creationId="{00000000-0000-0000-0000-000000000000}"/>
          </ac:picMkLst>
        </pc:picChg>
        <pc:picChg chg="mod">
          <ac:chgData name="Luke Flower" userId="VIGurbg40yMvIKMHIK2kyFqy7DkJde+0x8qwP7gx9no=" providerId="None" clId="Web-{BBEB0CBE-D9E2-4B1C-A0C2-4B887481E6F9}" dt="2025-01-06T16:20:03.035" v="51" actId="1076"/>
          <ac:picMkLst>
            <pc:docMk/>
            <pc:sldMk cId="0" sldId="257"/>
            <ac:picMk id="111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1"/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1944" y="323278"/>
            <a:ext cx="8042394" cy="6565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sz="1800" b="1" kern="1400" dirty="0">
                <a:solidFill>
                  <a:schemeClr val="bg1"/>
                </a:solidFill>
                <a:effectLst/>
                <a:latin typeface="Aptos Display" panose="020B0004020202020204" pitchFamily="34" charset="0"/>
                <a:ea typeface="Yu Gothic Light" panose="020B0300000000000000" pitchFamily="34" charset="-128"/>
                <a:cs typeface="Times New Roman (Headings CS)"/>
              </a:rPr>
              <a:t>The role of inflammasomes in acute respiratory distress syndrome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264B294-A22D-E5C7-E885-88E1200C0077}"/>
              </a:ext>
            </a:extLst>
          </p:cNvPr>
          <p:cNvGrpSpPr/>
          <p:nvPr/>
        </p:nvGrpSpPr>
        <p:grpSpPr>
          <a:xfrm>
            <a:off x="-7450" y="1706659"/>
            <a:ext cx="3180021" cy="3987882"/>
            <a:chOff x="32890" y="1708100"/>
            <a:chExt cx="3139681" cy="3986441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AF99871-28AC-3EBD-396B-D19920FF59EB}"/>
                </a:ext>
              </a:extLst>
            </p:cNvPr>
            <p:cNvSpPr txBox="1"/>
            <p:nvPr/>
          </p:nvSpPr>
          <p:spPr>
            <a:xfrm>
              <a:off x="32890" y="1708100"/>
              <a:ext cx="3139681" cy="39864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dirty="0"/>
            </a:p>
          </p:txBody>
        </p:sp>
        <p:sp>
          <p:nvSpPr>
            <p:cNvPr id="106" name="Google Shape;106;p1"/>
            <p:cNvSpPr txBox="1"/>
            <p:nvPr/>
          </p:nvSpPr>
          <p:spPr>
            <a:xfrm>
              <a:off x="579121" y="1709841"/>
              <a:ext cx="2593450" cy="3968842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200" dirty="0">
                  <a:solidFill>
                    <a:schemeClr val="tx1"/>
                  </a:solidFill>
                  <a:latin typeface="Aptos Display" panose="020B0004020202020204" pitchFamily="34" charset="0"/>
                </a:rPr>
                <a:t>Acute respiratory distress syndrome (ARDS) is present in &gt;10% of people admitted to intensive care and causes significant morbidity and mortality. </a:t>
              </a: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lang="en-US" sz="1200" b="1" dirty="0">
                <a:solidFill>
                  <a:srgbClr val="00B0F0"/>
                </a:solidFill>
                <a:latin typeface="Aptos Display" panose="020B0004020202020204" pitchFamily="34" charset="0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200" b="1" dirty="0">
                  <a:solidFill>
                    <a:srgbClr val="00B0F0"/>
                  </a:solidFill>
                  <a:latin typeface="Aptos Display" panose="020B0004020202020204" pitchFamily="34" charset="0"/>
                </a:rPr>
                <a:t>What is ARDS?</a:t>
              </a: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200" dirty="0">
                  <a:latin typeface="Aptos Display" panose="020B0004020202020204" pitchFamily="34" charset="0"/>
                </a:rPr>
                <a:t>ARDS is </a:t>
              </a:r>
              <a:r>
                <a:rPr lang="en-US" sz="1200" dirty="0" err="1">
                  <a:latin typeface="Aptos Display" panose="020B0004020202020204" pitchFamily="34" charset="0"/>
                </a:rPr>
                <a:t>characterised</a:t>
              </a:r>
              <a:r>
                <a:rPr lang="en-US" sz="1200" dirty="0">
                  <a:latin typeface="Aptos Display" panose="020B0004020202020204" pitchFamily="34" charset="0"/>
                </a:rPr>
                <a:t> by acute aberrant lung inflammation resulting in severe </a:t>
              </a:r>
              <a:r>
                <a:rPr lang="en-US" sz="1200" dirty="0" err="1">
                  <a:latin typeface="Aptos Display" panose="020B0004020202020204" pitchFamily="34" charset="0"/>
                </a:rPr>
                <a:t>hypoxaemia</a:t>
              </a:r>
              <a:r>
                <a:rPr lang="en-US" sz="1200" dirty="0">
                  <a:latin typeface="Aptos Display" panose="020B0004020202020204" pitchFamily="34" charset="0"/>
                </a:rPr>
                <a:t>. Effective therapies are lacking.</a:t>
              </a: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lang="en-US" sz="1200" b="1" i="0" u="none" strike="noStrike" cap="none" dirty="0">
                <a:solidFill>
                  <a:srgbClr val="00B0F0"/>
                </a:solidFill>
                <a:latin typeface="Aptos Display" panose="020B0004020202020204" pitchFamily="34" charset="0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200" b="1" i="0" u="none" strike="noStrike" cap="none" dirty="0">
                  <a:solidFill>
                    <a:srgbClr val="00B0F0"/>
                  </a:solidFill>
                  <a:latin typeface="Aptos Display" panose="020B0004020202020204" pitchFamily="34" charset="0"/>
                  <a:sym typeface="Arial"/>
                </a:rPr>
                <a:t>What drives ARDS?</a:t>
              </a: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Aptos Display" panose="020B0004020202020204" pitchFamily="34" charset="0"/>
                  <a:sym typeface="Arial"/>
                </a:rPr>
                <a:t>Inflammasome activation drives ARDS through the release of IL-1</a:t>
              </a:r>
              <a:r>
                <a:rPr lang="el-GR" sz="1200" b="0" i="0" u="none" strike="noStrike" cap="none" dirty="0">
                  <a:solidFill>
                    <a:srgbClr val="000000"/>
                  </a:solidFill>
                  <a:latin typeface="Aptos Display" panose="020B0004020202020204" pitchFamily="34" charset="0"/>
                  <a:sym typeface="Arial"/>
                </a:rPr>
                <a:t>ϐ</a:t>
              </a:r>
              <a:r>
                <a:rPr lang="en-US" sz="1200" b="0" i="0" u="none" strike="noStrike" cap="none" dirty="0">
                  <a:solidFill>
                    <a:srgbClr val="000000"/>
                  </a:solidFill>
                  <a:latin typeface="Aptos Display" panose="020B0004020202020204" pitchFamily="34" charset="0"/>
                  <a:sym typeface="Arial"/>
                </a:rPr>
                <a:t> and IL-18 by neutrophils and other immune cells. </a:t>
              </a: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lang="en-US" sz="1200" dirty="0">
                <a:solidFill>
                  <a:srgbClr val="00B0F0"/>
                </a:solidFill>
                <a:latin typeface="Aptos Display" panose="020B0004020202020204" pitchFamily="34" charset="0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en-US" sz="1200" b="1" dirty="0">
                  <a:solidFill>
                    <a:srgbClr val="00B0F0"/>
                  </a:solidFill>
                  <a:latin typeface="Aptos Display" panose="020B0004020202020204" pitchFamily="34" charset="0"/>
                </a:rPr>
                <a:t>What is next?</a:t>
              </a:r>
              <a:br>
                <a:rPr lang="en-US" sz="1200" dirty="0">
                  <a:latin typeface="Aptos Display" panose="020B0004020202020204" pitchFamily="34" charset="0"/>
                </a:rPr>
              </a:br>
              <a:r>
                <a:rPr lang="en-US" sz="1200" dirty="0">
                  <a:latin typeface="Aptos Display" panose="020B0004020202020204" pitchFamily="34" charset="0"/>
                </a:rPr>
                <a:t>Inflammasome blockade is an exciting potential ARDS treatment strategy, but further human-specific research is required. </a:t>
              </a:r>
              <a:endParaRPr lang="en-GB" sz="1200" dirty="0"/>
            </a:p>
          </p:txBody>
        </p:sp>
      </p:grp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A diagram of a blood vessel&#10;&#10;Description automatically generated">
            <a:extLst>
              <a:ext uri="{FF2B5EF4-FFF2-40B4-BE49-F238E27FC236}">
                <a16:creationId xmlns:a16="http://schemas.microsoft.com/office/drawing/2014/main" id="{E2DADB9B-345E-537D-5F9F-E5E115818827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7770" r="6500"/>
          <a:stretch/>
        </p:blipFill>
        <p:spPr>
          <a:xfrm>
            <a:off x="3385165" y="1708099"/>
            <a:ext cx="5759562" cy="398644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56C6380-94A6-5DE7-BC6C-B5D196AC8644}"/>
              </a:ext>
            </a:extLst>
          </p:cNvPr>
          <p:cNvSpPr txBox="1"/>
          <p:nvPr/>
        </p:nvSpPr>
        <p:spPr>
          <a:xfrm>
            <a:off x="105319" y="1055802"/>
            <a:ext cx="68447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F0"/>
                </a:solidFill>
              </a:rPr>
              <a:t>Flower et al. </a:t>
            </a:r>
            <a:r>
              <a:rPr lang="en-US" i="1" dirty="0">
                <a:solidFill>
                  <a:srgbClr val="00B0F0"/>
                </a:solidFill>
              </a:rPr>
              <a:t>Thorax </a:t>
            </a:r>
            <a:r>
              <a:rPr lang="en-US" dirty="0">
                <a:solidFill>
                  <a:srgbClr val="00B0F0"/>
                </a:solidFill>
              </a:rPr>
              <a:t>2024. </a:t>
            </a:r>
            <a:r>
              <a:rPr lang="en-US">
                <a:solidFill>
                  <a:srgbClr val="00B0F0"/>
                </a:solidFill>
              </a:rPr>
              <a:t>(do: 10.1136/thorax-2024-222596)</a:t>
            </a:r>
            <a:endParaRPr lang="en-GB" dirty="0">
              <a:solidFill>
                <a:srgbClr val="00B0F0"/>
              </a:solidFill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62E93B4-E0B8-268B-A4EE-02AD7E923D2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523" y="2705639"/>
            <a:ext cx="442645" cy="55123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8604C92-4556-AADA-FC5A-A400F9EE371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5568" y="4703987"/>
            <a:ext cx="503553" cy="49981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0DAF36A-0511-1935-DCFF-A6F60679E53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8523" y="3741095"/>
            <a:ext cx="442646" cy="48848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13CD06F-035D-44AF-CC8C-3D481F9875C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523" y="1768371"/>
            <a:ext cx="442646" cy="41483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8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 Display</vt:lpstr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antonio</dc:creator>
  <cp:lastModifiedBy>Jess Mark Ruadil</cp:lastModifiedBy>
  <cp:revision>44</cp:revision>
  <dcterms:created xsi:type="dcterms:W3CDTF">2018-02-16T17:34:16Z</dcterms:created>
  <dcterms:modified xsi:type="dcterms:W3CDTF">2025-01-08T06:52:29Z</dcterms:modified>
</cp:coreProperties>
</file>